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326C647-9CDE-426E-ADEC-5677A37C8658}" v="6" dt="2025-04-04T10:58:40.28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25" autoAdjust="0"/>
    <p:restoredTop sz="94660"/>
  </p:normalViewPr>
  <p:slideViewPr>
    <p:cSldViewPr snapToGrid="0">
      <p:cViewPr varScale="1">
        <p:scale>
          <a:sx n="79" d="100"/>
          <a:sy n="79" d="100"/>
        </p:scale>
        <p:origin x="75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ianshu Zhang" userId="486a4b88-34e6-42cf-9624-c2a311b60e9c" providerId="ADAL" clId="{8326C647-9CDE-426E-ADEC-5677A37C8658}"/>
    <pc:docChg chg="modSld">
      <pc:chgData name="Nianshu Zhang" userId="486a4b88-34e6-42cf-9624-c2a311b60e9c" providerId="ADAL" clId="{8326C647-9CDE-426E-ADEC-5677A37C8658}" dt="2025-04-04T10:59:42.450" v="154" actId="20577"/>
      <pc:docMkLst>
        <pc:docMk/>
      </pc:docMkLst>
      <pc:sldChg chg="addSp modSp mod">
        <pc:chgData name="Nianshu Zhang" userId="486a4b88-34e6-42cf-9624-c2a311b60e9c" providerId="ADAL" clId="{8326C647-9CDE-426E-ADEC-5677A37C8658}" dt="2025-04-04T10:59:42.450" v="154" actId="20577"/>
        <pc:sldMkLst>
          <pc:docMk/>
          <pc:sldMk cId="2558259268" sldId="256"/>
        </pc:sldMkLst>
        <pc:spChg chg="add mod">
          <ac:chgData name="Nianshu Zhang" userId="486a4b88-34e6-42cf-9624-c2a311b60e9c" providerId="ADAL" clId="{8326C647-9CDE-426E-ADEC-5677A37C8658}" dt="2025-04-04T10:59:42.450" v="154" actId="20577"/>
          <ac:spMkLst>
            <pc:docMk/>
            <pc:sldMk cId="2558259268" sldId="256"/>
            <ac:spMk id="2" creationId="{2F279473-75E7-9ED2-815F-C3017866D3CB}"/>
          </ac:spMkLst>
        </pc:spChg>
        <pc:spChg chg="add mod">
          <ac:chgData name="Nianshu Zhang" userId="486a4b88-34e6-42cf-9624-c2a311b60e9c" providerId="ADAL" clId="{8326C647-9CDE-426E-ADEC-5677A37C8658}" dt="2025-04-04T10:57:23.380" v="35" actId="554"/>
          <ac:spMkLst>
            <pc:docMk/>
            <pc:sldMk cId="2558259268" sldId="256"/>
            <ac:spMk id="3" creationId="{3AB8A094-4D87-7BF5-09B1-F2E1EB67467C}"/>
          </ac:spMkLst>
        </pc:spChg>
        <pc:spChg chg="add mod">
          <ac:chgData name="Nianshu Zhang" userId="486a4b88-34e6-42cf-9624-c2a311b60e9c" providerId="ADAL" clId="{8326C647-9CDE-426E-ADEC-5677A37C8658}" dt="2025-04-04T10:57:31.038" v="46" actId="20577"/>
          <ac:spMkLst>
            <pc:docMk/>
            <pc:sldMk cId="2558259268" sldId="256"/>
            <ac:spMk id="4" creationId="{6A953294-16E1-6109-A298-245CECDE6AC3}"/>
          </ac:spMkLst>
        </pc:spChg>
        <pc:spChg chg="add mod">
          <ac:chgData name="Nianshu Zhang" userId="486a4b88-34e6-42cf-9624-c2a311b60e9c" providerId="ADAL" clId="{8326C647-9CDE-426E-ADEC-5677A37C8658}" dt="2025-04-04T10:59:06.230" v="96" actId="554"/>
          <ac:spMkLst>
            <pc:docMk/>
            <pc:sldMk cId="2558259268" sldId="256"/>
            <ac:spMk id="6" creationId="{7426572A-B09A-E7C4-55F0-BC7F1DD48349}"/>
          </ac:spMkLst>
        </pc:spChg>
        <pc:spChg chg="add mod">
          <ac:chgData name="Nianshu Zhang" userId="486a4b88-34e6-42cf-9624-c2a311b60e9c" providerId="ADAL" clId="{8326C647-9CDE-426E-ADEC-5677A37C8658}" dt="2025-04-04T10:59:06.230" v="96" actId="554"/>
          <ac:spMkLst>
            <pc:docMk/>
            <pc:sldMk cId="2558259268" sldId="256"/>
            <ac:spMk id="8" creationId="{98347023-B9BE-FAA3-CD18-F3C31EB2E8F4}"/>
          </ac:spMkLst>
        </pc:spChg>
        <pc:picChg chg="mod">
          <ac:chgData name="Nianshu Zhang" userId="486a4b88-34e6-42cf-9624-c2a311b60e9c" providerId="ADAL" clId="{8326C647-9CDE-426E-ADEC-5677A37C8658}" dt="2025-04-04T10:55:47.065" v="3" actId="1076"/>
          <ac:picMkLst>
            <pc:docMk/>
            <pc:sldMk cId="2558259268" sldId="256"/>
            <ac:picMk id="5" creationId="{BDF96CDF-356F-2E55-53E0-219EED7128FE}"/>
          </ac:picMkLst>
        </pc:picChg>
        <pc:picChg chg="mod">
          <ac:chgData name="Nianshu Zhang" userId="486a4b88-34e6-42cf-9624-c2a311b60e9c" providerId="ADAL" clId="{8326C647-9CDE-426E-ADEC-5677A37C8658}" dt="2025-04-04T10:55:54.237" v="6" actId="1076"/>
          <ac:picMkLst>
            <pc:docMk/>
            <pc:sldMk cId="2558259268" sldId="256"/>
            <ac:picMk id="7" creationId="{4DC64BAD-A841-4659-90F8-C113E576728B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96BC58-BEDA-8732-32A1-FD25981CC1D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9FF3714-8064-99EF-C70C-861FC7960F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A4843A-6173-A1E4-439D-3FEEB23D02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D873-1249-475B-B044-96D9F1386D77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C0DC28-1684-2C62-E90D-E3BDA77607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516696-7F96-709D-FBA2-51D71A1368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A225-9DF0-44BC-B3DE-AD3808B60A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9819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6B51A1-45CB-509C-8B27-CBDF78C143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B4327C-ECC5-B499-E29E-44C1D54BC4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B048F8-4BCE-C1ED-5BB7-3FC38544BD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D873-1249-475B-B044-96D9F1386D77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EC06EC-6729-0CDA-034D-5CADA79CD3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58F3E7-2021-E589-F9F1-89B43A3DFF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A225-9DF0-44BC-B3DE-AD3808B60A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86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148C961-6A7B-6ADA-FEA5-5AF4B0BF9A8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A7923D-3BDE-DE22-29B7-61169A62A3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9205F5-2881-7DBA-502A-E630EE782A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D873-1249-475B-B044-96D9F1386D77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7AAAB2-2316-77C1-A988-054D78D85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34DB1A-9B5C-941C-02C3-AA6FEF076B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A225-9DF0-44BC-B3DE-AD3808B60A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6282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13F4EC-45C1-420C-E815-55E046238A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251704-DFA9-E8A3-4891-9993B301CC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533CBD-2EAC-8A91-07F2-69DB7931A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D873-1249-475B-B044-96D9F1386D77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A15D67-FF6A-CB58-C198-C4CD599EF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848426-FBE0-B2D0-EB07-E6D6246E01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A225-9DF0-44BC-B3DE-AD3808B60A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69112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D0A65C-1A8B-B9C2-084B-BF2D7400BC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DF1840-19CE-55D6-C4F5-4F0E4860F1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0B57E0-6056-9675-B2DD-5FE17EF89F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D873-1249-475B-B044-96D9F1386D77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175785-72B5-A7E0-FDC9-5ADC339A12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00E5B3-1ADE-AD53-7A35-17B4C540B8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A225-9DF0-44BC-B3DE-AD3808B60A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6288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238B60-2796-CB25-5808-D1F82F9B45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9F3621-1D1D-C835-2399-ED43CAD42AF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0EBC2F-0106-B29F-86BC-AB4910FF34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A1397E-FA61-07F7-F9AC-A24792D325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D873-1249-475B-B044-96D9F1386D77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6C0284-01C1-C31A-3A4A-ADD94E4C4A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88F05B-7704-DE77-4922-F4EFA9823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A225-9DF0-44BC-B3DE-AD3808B60A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566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F97076-2BB0-850A-1408-3E1BA2BFC5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43DF84-204E-A597-7106-BEDCE874B2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61A8D9-F995-4627-8A1E-FE5900B4F4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6560995-AB1C-C614-58C4-A37E5FC628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A1EDE93-89C9-3C29-4D43-3A07962633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3F1F78-E48C-FEA4-C059-B500D33BEF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D873-1249-475B-B044-96D9F1386D77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4A438B-D4D0-FD67-F265-1B045D07F7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7A01861-21F9-DC6F-FD20-9374E57587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A225-9DF0-44BC-B3DE-AD3808B60A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9147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1190F2-FA5D-4000-FA2C-2E65D57C8D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6D0C661-1A48-9A3D-8E0F-C840DD01F8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D873-1249-475B-B044-96D9F1386D77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BA92312-756B-75BF-C9C7-85944C0FA1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DE4DBCB-CB25-F6C8-6E52-FA9827502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A225-9DF0-44BC-B3DE-AD3808B60A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2449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9D14484-69D1-1F5C-8A07-D1965A178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D873-1249-475B-B044-96D9F1386D77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E654EE5-715C-07B4-E112-0DE58FEFD6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C132A0-6672-DA5F-91BA-9B0CE86C9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A225-9DF0-44BC-B3DE-AD3808B60A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6327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FD59FC-A50F-B503-0BB1-15D216E338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FBFCE8-1B34-D529-4FB0-1EDDB88235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610909-E156-AB7D-BFF2-7FF2C7D3A8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3864B4-446D-594A-4C2E-0F5CA2549B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D873-1249-475B-B044-96D9F1386D77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D293F9-9152-DA4C-E248-ADDD95C37A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262394-4208-F855-7C13-1326129F52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A225-9DF0-44BC-B3DE-AD3808B60A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4100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B56091-DD42-5172-5722-D3A17D15EA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95D1B2-2E26-5D23-03B1-A73B6F8ED5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5C352A-9A3C-97DA-1926-A2B2ABF4CE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C8FD0C-0AA5-1775-C3EA-2A2751A753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D873-1249-475B-B044-96D9F1386D77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1B6D33-A677-3F1D-B8FD-C751CC5B13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8459CB-6DA6-A001-B532-D53B3EB12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A225-9DF0-44BC-B3DE-AD3808B60A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8334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05FC68B-C0C2-C4BD-3FB8-D6CAC2F55A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BE85C9-BA52-2755-E284-2AE8F16B80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B2FE06-B504-FE0A-E89D-A40F96D7AF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47AD873-1249-475B-B044-96D9F1386D77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AB3049-21BB-08EA-57CD-D743DCB7236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0F9983-629F-2CD9-8035-6FAD8A308D9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478A225-9DF0-44BC-B3DE-AD3808B60A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1479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with numbers and letters&#10;&#10;AI-generated content may be incorrect.">
            <a:extLst>
              <a:ext uri="{FF2B5EF4-FFF2-40B4-BE49-F238E27FC236}">
                <a16:creationId xmlns:a16="http://schemas.microsoft.com/office/drawing/2014/main" id="{BDF96CDF-356F-2E55-53E0-219EED7128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4706" y="1521748"/>
            <a:ext cx="4107508" cy="2879721"/>
          </a:xfrm>
          <a:prstGeom prst="rect">
            <a:avLst/>
          </a:prstGeom>
        </p:spPr>
      </p:pic>
      <p:pic>
        <p:nvPicPr>
          <p:cNvPr id="7" name="Picture 6" descr="A graph showing the different types of pds&#10;&#10;AI-generated content may be incorrect.">
            <a:extLst>
              <a:ext uri="{FF2B5EF4-FFF2-40B4-BE49-F238E27FC236}">
                <a16:creationId xmlns:a16="http://schemas.microsoft.com/office/drawing/2014/main" id="{4DC64BAD-A841-4659-90F8-C113E576728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521748"/>
            <a:ext cx="4040835" cy="2825822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2F279473-75E7-9ED2-815F-C3017866D3CB}"/>
              </a:ext>
            </a:extLst>
          </p:cNvPr>
          <p:cNvSpPr/>
          <p:nvPr/>
        </p:nvSpPr>
        <p:spPr>
          <a:xfrm>
            <a:off x="2035006" y="5013086"/>
            <a:ext cx="842222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pplemental File S4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. PCA analysis of the </a:t>
            </a:r>
            <a:r>
              <a:rPr lang="en-US" sz="1200" kern="100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hosphoproteome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at the phosphorylation (A) and the occupancy (B) levels. </a:t>
            </a:r>
            <a:endParaRPr lang="en-GB" sz="1200" kern="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 </a:t>
            </a:r>
            <a:endParaRPr lang="en-GB" sz="1200" kern="100" dirty="0">
              <a:effectLst/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AB8A094-4D87-7BF5-09B1-F2E1EB67467C}"/>
              </a:ext>
            </a:extLst>
          </p:cNvPr>
          <p:cNvSpPr txBox="1"/>
          <p:nvPr/>
        </p:nvSpPr>
        <p:spPr>
          <a:xfrm>
            <a:off x="3026003" y="4374551"/>
            <a:ext cx="15183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Phosphorylation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A953294-16E1-6109-A298-245CECDE6AC3}"/>
              </a:ext>
            </a:extLst>
          </p:cNvPr>
          <p:cNvSpPr txBox="1"/>
          <p:nvPr/>
        </p:nvSpPr>
        <p:spPr>
          <a:xfrm>
            <a:off x="7357235" y="4374551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Occupancy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426572A-B09A-E7C4-55F0-BC7F1DD48349}"/>
              </a:ext>
            </a:extLst>
          </p:cNvPr>
          <p:cNvSpPr txBox="1"/>
          <p:nvPr/>
        </p:nvSpPr>
        <p:spPr>
          <a:xfrm>
            <a:off x="1734245" y="96341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8347023-B9BE-FAA3-CD18-F3C31EB2E8F4}"/>
              </a:ext>
            </a:extLst>
          </p:cNvPr>
          <p:cNvSpPr txBox="1"/>
          <p:nvPr/>
        </p:nvSpPr>
        <p:spPr>
          <a:xfrm>
            <a:off x="6096000" y="96341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5582592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28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ianshu Zhang</dc:creator>
  <cp:lastModifiedBy>MDPI</cp:lastModifiedBy>
  <cp:revision>2</cp:revision>
  <dcterms:created xsi:type="dcterms:W3CDTF">2025-03-07T18:02:29Z</dcterms:created>
  <dcterms:modified xsi:type="dcterms:W3CDTF">2025-04-09T11:10:14Z</dcterms:modified>
</cp:coreProperties>
</file>